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</p:sldIdLst>
  <p:sldSz cx="12192000" cy="6858000"/>
  <p:notesSz cx="6735763" cy="9866313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88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ri Lerstøl Olsen" userId="65a127d3-5670-4efe-be28-65f793256cd7" providerId="ADAL" clId="{7787DD7E-05B1-4405-B082-47EFEB5A4547}"/>
    <pc:docChg chg="modSld">
      <pc:chgData name="Siri Lerstøl Olsen" userId="65a127d3-5670-4efe-be28-65f793256cd7" providerId="ADAL" clId="{7787DD7E-05B1-4405-B082-47EFEB5A4547}" dt="2022-10-14T08:07:17.379" v="28" actId="1076"/>
      <pc:docMkLst>
        <pc:docMk/>
      </pc:docMkLst>
      <pc:sldChg chg="modSp mod">
        <pc:chgData name="Siri Lerstøl Olsen" userId="65a127d3-5670-4efe-be28-65f793256cd7" providerId="ADAL" clId="{7787DD7E-05B1-4405-B082-47EFEB5A4547}" dt="2022-10-14T08:07:17.379" v="28" actId="1076"/>
        <pc:sldMkLst>
          <pc:docMk/>
          <pc:sldMk cId="1456877064" sldId="293"/>
        </pc:sldMkLst>
        <pc:spChg chg="mod">
          <ac:chgData name="Siri Lerstøl Olsen" userId="65a127d3-5670-4efe-be28-65f793256cd7" providerId="ADAL" clId="{7787DD7E-05B1-4405-B082-47EFEB5A4547}" dt="2022-10-14T08:07:17.379" v="28" actId="1076"/>
          <ac:spMkLst>
            <pc:docMk/>
            <pc:sldMk cId="1456877064" sldId="293"/>
            <ac:spMk id="6" creationId="{BFCB13D4-C1B5-4119-AAE5-6475434D7330}"/>
          </ac:spMkLst>
        </pc:spChg>
        <pc:spChg chg="mod">
          <ac:chgData name="Siri Lerstøl Olsen" userId="65a127d3-5670-4efe-be28-65f793256cd7" providerId="ADAL" clId="{7787DD7E-05B1-4405-B082-47EFEB5A4547}" dt="2022-10-11T12:22:41.715" v="9" actId="20577"/>
          <ac:spMkLst>
            <pc:docMk/>
            <pc:sldMk cId="1456877064" sldId="293"/>
            <ac:spMk id="10" creationId="{0343CB7C-AA43-EDF1-48A5-2E3976FC674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4A6F42A-01F5-4C6F-A00C-0816A6EC6F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74DE768D-CB66-4BCF-9F7C-A32FA3CB31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8DCB7D12-2F00-4F2E-8756-983877425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5303FDCE-029A-40BB-8394-0DB64CD0A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E0BD36C-DF42-4CAE-87DB-578784C56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31235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76EBA8A-964F-4B95-8DB6-40027156E0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AD27EE8E-ADEA-4E87-A380-95E837074D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1FF48BC6-E20B-4BDC-903A-70A858310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507B6FA-7357-4233-BCAE-DA2D5E220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C552D743-68F5-4581-AF93-F3BC6D501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50604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ED6A1E95-0FF8-4437-A1A2-9201BFABDC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CA9B7D7D-F0DD-4F7E-8D12-75814528C9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1200EC70-EC9C-4C28-820F-52A3FD3F2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BC169BA6-E043-434F-BD6F-6E175D9B3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C67401C1-4DC1-4DD4-B038-41407AA53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34980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DAAAD51-D0FC-4AE6-909D-525EDE6BD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7FDC94F6-2AA0-4630-9B60-A8DF971391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120F0316-26A2-4C9C-BAEA-C49E7003F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9CA306E1-EA43-422A-929A-7E9F44165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9D593F84-4FA9-41A9-B319-BC7BEE768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13388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D29F0F8-BDA8-4CFF-B333-7B554618D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4E6AFB10-8014-4179-B164-F27B57CBFC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13B9DE7-77DB-4B71-B189-7C75CBDF7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A29757EF-19C4-4FAE-9DED-226CE770B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AE683121-9C68-40C8-8A68-52795D13C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7144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445CB3A-AB5F-4CBD-B65B-320F0BC99E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273DA8A-2808-43CB-8BFB-D6067F4607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25E9E3B4-E833-4B19-9E22-93A3229A99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040A85CF-9276-4EDC-BE97-B6D15BE51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E2B6E9C-50E0-4831-B44F-5C53AD3A2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1D6E19B-9321-4538-AE50-A459D8AAE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75568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BAAE6FB-1249-4D33-83CD-8542B704D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0EB369BB-5554-4E76-ACEC-05C7DBA4E4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D4FEAA77-7578-4DCD-A41E-978FB2468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382FB6A5-085D-479E-8E27-682CE4008C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A725C492-58EF-4CAF-818A-2F1D4AC5A0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0906FB23-D9CD-4B8B-A6CA-AB2615BF2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BBEA710C-06BC-4E22-83FB-4ED6CEFD9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72377AE8-872D-4874-9300-1E6DB9AF5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61941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6DAF625-FDA8-46A8-839D-C99C284F5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95A8E0FC-8BCF-4C98-81CB-89636FA10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E57C59BC-45AF-4FB1-BA35-0E600AC78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BEDD85CC-F675-43F5-83D7-4102EE85B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29305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40C99115-9F62-4A4C-B684-10C3BB1BC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AD2750A5-C0C1-4434-8C93-AA44E1693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5B10B9BA-3061-46E6-A714-C91110124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25995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029D5114-C0F9-413F-A951-63C7A8530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2CA21FA5-E313-4585-B3FD-197ECD185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94889EF-4D31-48C2-91F1-1BEEC6792D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945E0AD-4F24-4311-B7B3-7B737EEAA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CABC1272-D37C-46E3-8FDD-82D97BEBF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D9A87282-4314-42A3-8BDD-49606C60C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50276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3807C6C-6705-4AEE-A825-CA592A546B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185402E6-4C94-469F-806D-F2127E2E65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DA4B938C-D43A-4739-926B-2527CDB706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7367E118-AF0B-40B0-828B-F400E9133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212E1C77-61DC-4E1B-9806-4A3DF1395B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827858B1-816E-447B-A163-6629D68F4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157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D887E451-3F93-410F-B4C3-BA69FC6056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009D1797-5F24-419F-B662-60DE834E64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07EC71AD-7B14-458A-839A-FDE96029AE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7CB59-CFCC-44AD-8B6A-2D51AD6CB89B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0AE5B51F-EC66-4157-A871-FAA07E23A3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1608C13-F292-4BE4-9202-10D507D473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2971F-57E2-448C-A8BB-959A78E4636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00557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Sylinder 1"/>
          <p:cNvSpPr txBox="1"/>
          <p:nvPr/>
        </p:nvSpPr>
        <p:spPr>
          <a:xfrm>
            <a:off x="2063552" y="1196752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nb-NO" dirty="0"/>
          </a:p>
        </p:txBody>
      </p:sp>
      <p:pic>
        <p:nvPicPr>
          <p:cNvPr id="3" name="Bild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1049" y="1580520"/>
            <a:ext cx="2149278" cy="3624902"/>
          </a:xfrm>
          <a:prstGeom prst="rect">
            <a:avLst/>
          </a:prstGeom>
        </p:spPr>
      </p:pic>
      <p:pic>
        <p:nvPicPr>
          <p:cNvPr id="4" name="Bild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4307" y="1496253"/>
            <a:ext cx="2348620" cy="3580131"/>
          </a:xfrm>
          <a:prstGeom prst="rect">
            <a:avLst/>
          </a:prstGeom>
        </p:spPr>
      </p:pic>
      <p:pic>
        <p:nvPicPr>
          <p:cNvPr id="5" name="Bilde 4"/>
          <p:cNvPicPr/>
          <p:nvPr/>
        </p:nvPicPr>
        <p:blipFill>
          <a:blip r:embed="rId4"/>
          <a:stretch>
            <a:fillRect/>
          </a:stretch>
        </p:blipFill>
        <p:spPr>
          <a:xfrm>
            <a:off x="7976907" y="1566084"/>
            <a:ext cx="2190317" cy="3362466"/>
          </a:xfrm>
          <a:prstGeom prst="rect">
            <a:avLst/>
          </a:prstGeom>
        </p:spPr>
      </p:pic>
      <p:sp>
        <p:nvSpPr>
          <p:cNvPr id="6" name="TekstSylinder 5">
            <a:extLst>
              <a:ext uri="{FF2B5EF4-FFF2-40B4-BE49-F238E27FC236}">
                <a16:creationId xmlns:a16="http://schemas.microsoft.com/office/drawing/2014/main" id="{BFCB13D4-C1B5-4119-AAE5-6475434D7330}"/>
              </a:ext>
            </a:extLst>
          </p:cNvPr>
          <p:cNvSpPr txBox="1"/>
          <p:nvPr/>
        </p:nvSpPr>
        <p:spPr>
          <a:xfrm>
            <a:off x="670346" y="5247420"/>
            <a:ext cx="10321158" cy="156100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l. File 3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Development of patient OM-chart. In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o room for respiratory frequency documentation. In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2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ew charts developed when the MET- c criteria was implemented. In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3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EWS is incorporated in the chart. All vital signs are documented both in the top of the chart, and in the bottom as NEW -score. By clicking on the numbers, detailed information about time for registration and all vital sign values are available.</a:t>
            </a:r>
            <a:endParaRPr lang="nb-NO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D652AA36-E22B-4CEA-95E8-B2F9E655CE77}"/>
              </a:ext>
            </a:extLst>
          </p:cNvPr>
          <p:cNvSpPr txBox="1"/>
          <p:nvPr/>
        </p:nvSpPr>
        <p:spPr>
          <a:xfrm>
            <a:off x="2270812" y="1145411"/>
            <a:ext cx="509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1</a:t>
            </a:r>
          </a:p>
        </p:txBody>
      </p:sp>
      <p:sp>
        <p:nvSpPr>
          <p:cNvPr id="8" name="TekstSylinder 7">
            <a:extLst>
              <a:ext uri="{FF2B5EF4-FFF2-40B4-BE49-F238E27FC236}">
                <a16:creationId xmlns:a16="http://schemas.microsoft.com/office/drawing/2014/main" id="{FBA8B130-AE8A-4F7F-A6A8-545289D332B5}"/>
              </a:ext>
            </a:extLst>
          </p:cNvPr>
          <p:cNvSpPr txBox="1"/>
          <p:nvPr/>
        </p:nvSpPr>
        <p:spPr>
          <a:xfrm>
            <a:off x="5576050" y="1151373"/>
            <a:ext cx="509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2</a:t>
            </a:r>
          </a:p>
        </p:txBody>
      </p:sp>
      <p:sp>
        <p:nvSpPr>
          <p:cNvPr id="9" name="TekstSylinder 8">
            <a:extLst>
              <a:ext uri="{FF2B5EF4-FFF2-40B4-BE49-F238E27FC236}">
                <a16:creationId xmlns:a16="http://schemas.microsoft.com/office/drawing/2014/main" id="{2A786E6E-50F6-4F81-93BA-FE01988EAFFB}"/>
              </a:ext>
            </a:extLst>
          </p:cNvPr>
          <p:cNvSpPr txBox="1"/>
          <p:nvPr/>
        </p:nvSpPr>
        <p:spPr>
          <a:xfrm>
            <a:off x="8881288" y="1211188"/>
            <a:ext cx="509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P3</a:t>
            </a:r>
          </a:p>
        </p:txBody>
      </p:sp>
      <p:sp>
        <p:nvSpPr>
          <p:cNvPr id="10" name="TekstSylinder 9">
            <a:extLst>
              <a:ext uri="{FF2B5EF4-FFF2-40B4-BE49-F238E27FC236}">
                <a16:creationId xmlns:a16="http://schemas.microsoft.com/office/drawing/2014/main" id="{0343CB7C-AA43-EDF1-48A5-2E3976FC674A}"/>
              </a:ext>
            </a:extLst>
          </p:cNvPr>
          <p:cNvSpPr txBox="1"/>
          <p:nvPr/>
        </p:nvSpPr>
        <p:spPr>
          <a:xfrm>
            <a:off x="1681566" y="472698"/>
            <a:ext cx="8214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Examples of the charts with documented vital signs used in the three </a:t>
            </a:r>
            <a:r>
              <a:rPr lang="en-GB" b="1"/>
              <a:t>time periods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456877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03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Siri Lerstøl Olsen</dc:creator>
  <cp:lastModifiedBy>Siri Lerstøl Olsen</cp:lastModifiedBy>
  <cp:revision>2</cp:revision>
  <cp:lastPrinted>2022-07-01T10:31:11Z</cp:lastPrinted>
  <dcterms:created xsi:type="dcterms:W3CDTF">2022-07-01T10:29:33Z</dcterms:created>
  <dcterms:modified xsi:type="dcterms:W3CDTF">2022-10-14T08:07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b7fce66-bf2d-46b5-b59a-9f0018501bcd_Enabled">
    <vt:lpwstr>true</vt:lpwstr>
  </property>
  <property fmtid="{D5CDD505-2E9C-101B-9397-08002B2CF9AE}" pid="3" name="MSIP_Label_2b7fce66-bf2d-46b5-b59a-9f0018501bcd_SetDate">
    <vt:lpwstr>2022-07-01T10:29:33Z</vt:lpwstr>
  </property>
  <property fmtid="{D5CDD505-2E9C-101B-9397-08002B2CF9AE}" pid="4" name="MSIP_Label_2b7fce66-bf2d-46b5-b59a-9f0018501bcd_Method">
    <vt:lpwstr>Standard</vt:lpwstr>
  </property>
  <property fmtid="{D5CDD505-2E9C-101B-9397-08002B2CF9AE}" pid="5" name="MSIP_Label_2b7fce66-bf2d-46b5-b59a-9f0018501bcd_Name">
    <vt:lpwstr>s_Intern</vt:lpwstr>
  </property>
  <property fmtid="{D5CDD505-2E9C-101B-9397-08002B2CF9AE}" pid="6" name="MSIP_Label_2b7fce66-bf2d-46b5-b59a-9f0018501bcd_SiteId">
    <vt:lpwstr>f8a213d2-8f6c-400d-9e74-4e8b475316c6</vt:lpwstr>
  </property>
  <property fmtid="{D5CDD505-2E9C-101B-9397-08002B2CF9AE}" pid="7" name="MSIP_Label_2b7fce66-bf2d-46b5-b59a-9f0018501bcd_ActionId">
    <vt:lpwstr>9405d2de-a7e4-422f-a025-52f6f4e75c96</vt:lpwstr>
  </property>
  <property fmtid="{D5CDD505-2E9C-101B-9397-08002B2CF9AE}" pid="8" name="MSIP_Label_2b7fce66-bf2d-46b5-b59a-9f0018501bcd_ContentBits">
    <vt:lpwstr>0</vt:lpwstr>
  </property>
</Properties>
</file>